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8"/>
  </p:notesMasterIdLst>
  <p:sldIdLst>
    <p:sldId id="743" r:id="rId2"/>
    <p:sldId id="429" r:id="rId3"/>
    <p:sldId id="399" r:id="rId4"/>
    <p:sldId id="403" r:id="rId5"/>
    <p:sldId id="405" r:id="rId6"/>
    <p:sldId id="406" r:id="rId7"/>
    <p:sldId id="410" r:id="rId8"/>
    <p:sldId id="413" r:id="rId9"/>
    <p:sldId id="427" r:id="rId10"/>
    <p:sldId id="738" r:id="rId11"/>
    <p:sldId id="735" r:id="rId12"/>
    <p:sldId id="626" r:id="rId13"/>
    <p:sldId id="650" r:id="rId14"/>
    <p:sldId id="737" r:id="rId15"/>
    <p:sldId id="430" r:id="rId16"/>
    <p:sldId id="733" r:id="rId17"/>
    <p:sldId id="654" r:id="rId18"/>
    <p:sldId id="656" r:id="rId19"/>
    <p:sldId id="739" r:id="rId20"/>
    <p:sldId id="416" r:id="rId21"/>
    <p:sldId id="419" r:id="rId22"/>
    <p:sldId id="734" r:id="rId23"/>
    <p:sldId id="395" r:id="rId24"/>
    <p:sldId id="396" r:id="rId25"/>
    <p:sldId id="741" r:id="rId26"/>
    <p:sldId id="742" r:id="rId2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710" autoAdjust="0"/>
  </p:normalViewPr>
  <p:slideViewPr>
    <p:cSldViewPr snapToGrid="0">
      <p:cViewPr varScale="1">
        <p:scale>
          <a:sx n="108" d="100"/>
          <a:sy n="108" d="100"/>
        </p:scale>
        <p:origin x="60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668A2A-20A7-4D06-95D1-2A28E7FA6D53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A22389-83F8-469F-9090-905A41E96C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0876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A22389-83F8-469F-9090-905A41E96C7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94402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4A22389-83F8-469F-9090-905A41E96C77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5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07193229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hmdb.ca/metabolites/HMDB0242648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38CEB-FCEE-4CE4-BDC5-8FC1C463DCD7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6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05964157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38CEB-FCEE-4CE4-BDC5-8FC1C463DCD7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7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034157369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770D4F-12D4-405C-9FE6-161E46A93927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306993836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01C0769-7CB4-4825-92C7-868FBF92EE15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3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571419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01C0769-7CB4-4825-92C7-868FBF92EE15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1221120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01C0769-7CB4-4825-92C7-868FBF92EE15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9836934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01C0769-7CB4-4825-92C7-868FBF92EE15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4203707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01C0769-7CB4-4825-92C7-868FBF92EE15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7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3004736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NFUSING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01C0769-7CB4-4825-92C7-868FBF92EE15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8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598596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A22389-83F8-469F-9090-905A41E96C77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44882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br>
              <a:rPr lang="en-US" dirty="0"/>
            </a:b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2D38CEB-FCEE-4CE4-BDC5-8FC1C463DCD7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03588884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770D4F-12D4-405C-9FE6-161E46A93927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4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8033344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510E9-4E22-4F0B-9A62-66DB4476C512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5A141-E15C-47F7-A9B7-D504C4102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358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510E9-4E22-4F0B-9A62-66DB4476C512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5A141-E15C-47F7-A9B7-D504C4102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104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510E9-4E22-4F0B-9A62-66DB4476C512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5A141-E15C-47F7-A9B7-D504C4102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935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510E9-4E22-4F0B-9A62-66DB4476C512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5A141-E15C-47F7-A9B7-D504C4102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525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510E9-4E22-4F0B-9A62-66DB4476C512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5A141-E15C-47F7-A9B7-D504C4102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114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510E9-4E22-4F0B-9A62-66DB4476C512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5A141-E15C-47F7-A9B7-D504C4102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941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510E9-4E22-4F0B-9A62-66DB4476C512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5A141-E15C-47F7-A9B7-D504C4102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632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510E9-4E22-4F0B-9A62-66DB4476C512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5A141-E15C-47F7-A9B7-D504C4102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313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510E9-4E22-4F0B-9A62-66DB4476C512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5A141-E15C-47F7-A9B7-D504C4102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590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510E9-4E22-4F0B-9A62-66DB4476C512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5A141-E15C-47F7-A9B7-D504C4102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796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510E9-4E22-4F0B-9A62-66DB4476C512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5A141-E15C-47F7-A9B7-D504C4102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086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7510E9-4E22-4F0B-9A62-66DB4476C512}" type="datetimeFigureOut">
              <a:rPr lang="en-US" smtClean="0"/>
              <a:t>8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5A141-E15C-47F7-A9B7-D504C4102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0219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5.bin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wmf"/><Relationship Id="rId5" Type="http://schemas.openxmlformats.org/officeDocument/2006/relationships/oleObject" Target="../embeddings/oleObject16.bin"/><Relationship Id="rId4" Type="http://schemas.openxmlformats.org/officeDocument/2006/relationships/image" Target="../media/image24.wmf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7.wmf"/><Relationship Id="rId4" Type="http://schemas.openxmlformats.org/officeDocument/2006/relationships/oleObject" Target="../embeddings/oleObject17.bin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8.bin"/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9.w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wmf"/><Relationship Id="rId4" Type="http://schemas.openxmlformats.org/officeDocument/2006/relationships/oleObject" Target="../embeddings/oleObject19.bin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3.wmf"/><Relationship Id="rId4" Type="http://schemas.openxmlformats.org/officeDocument/2006/relationships/oleObject" Target="../embeddings/oleObject20.bin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5.wmf"/><Relationship Id="rId4" Type="http://schemas.openxmlformats.org/officeDocument/2006/relationships/oleObject" Target="../embeddings/oleObject21.bin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2.bin"/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7.wmf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3.bin"/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9.wmf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1.wmf"/><Relationship Id="rId4" Type="http://schemas.openxmlformats.org/officeDocument/2006/relationships/oleObject" Target="../embeddings/oleObject24.bin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3.wmf"/><Relationship Id="rId4" Type="http://schemas.openxmlformats.org/officeDocument/2006/relationships/oleObject" Target="../embeddings/oleObject25.bin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6.bin"/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5.wmf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7.bin"/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7.wmf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8.bin"/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9.w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image" Target="../media/image2.emf"/><Relationship Id="rId7" Type="http://schemas.openxmlformats.org/officeDocument/2006/relationships/image" Target="../media/image4.w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.w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5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7" Type="http://schemas.openxmlformats.org/officeDocument/2006/relationships/image" Target="../media/image8.w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7.wmf"/><Relationship Id="rId4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w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10.w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7" Type="http://schemas.openxmlformats.org/officeDocument/2006/relationships/image" Target="../media/image14.w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13.wmf"/><Relationship Id="rId4" Type="http://schemas.openxmlformats.org/officeDocument/2006/relationships/oleObject" Target="../embeddings/oleObject8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7" Type="http://schemas.openxmlformats.org/officeDocument/2006/relationships/image" Target="../media/image5.w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6.wmf"/><Relationship Id="rId4" Type="http://schemas.openxmlformats.org/officeDocument/2006/relationships/oleObject" Target="../embeddings/oleObject10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wmf"/><Relationship Id="rId4" Type="http://schemas.openxmlformats.org/officeDocument/2006/relationships/oleObject" Target="../embeddings/oleObject11.bin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wmf"/><Relationship Id="rId3" Type="http://schemas.openxmlformats.org/officeDocument/2006/relationships/oleObject" Target="../embeddings/oleObject12.bin"/><Relationship Id="rId7" Type="http://schemas.openxmlformats.org/officeDocument/2006/relationships/oleObject" Target="../embeddings/oleObject14.bin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w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20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78A8B16-2F4F-9BF9-45AC-E2435C00AAAF}"/>
              </a:ext>
            </a:extLst>
          </p:cNvPr>
          <p:cNvSpPr txBox="1"/>
          <p:nvPr/>
        </p:nvSpPr>
        <p:spPr>
          <a:xfrm>
            <a:off x="2372557" y="500980"/>
            <a:ext cx="6094520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orting data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DA1D031-4FDE-06F9-1DE5-C1F1A2AF12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7289" y="1229373"/>
            <a:ext cx="2948940" cy="2552700"/>
          </a:xfrm>
          <a:prstGeom prst="rect">
            <a:avLst/>
          </a:prstGeom>
          <a:noFill/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2C1A0B9-2293-9A40-E9C3-BC117428C80D}"/>
              </a:ext>
            </a:extLst>
          </p:cNvPr>
          <p:cNvSpPr txBox="1"/>
          <p:nvPr/>
        </p:nvSpPr>
        <p:spPr>
          <a:xfrm>
            <a:off x="790113" y="3930500"/>
            <a:ext cx="10928411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. Fig. S1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hows the excisional view of the dorsal back wound region in all animals on day 0 prior to therapy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367623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4137" y="1550689"/>
            <a:ext cx="10183726" cy="375662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BF77AF8-829B-B451-66FF-59AE860C798E}"/>
              </a:ext>
            </a:extLst>
          </p:cNvPr>
          <p:cNvSpPr txBox="1"/>
          <p:nvPr/>
        </p:nvSpPr>
        <p:spPr>
          <a:xfrm>
            <a:off x="5103594" y="1181357"/>
            <a:ext cx="2834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Curassavin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 N-oxide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46B5A88A-273D-06E0-D62A-B5CC0E22E6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8865982"/>
              </p:ext>
            </p:extLst>
          </p:nvPr>
        </p:nvGraphicFramePr>
        <p:xfrm>
          <a:off x="7389464" y="1833292"/>
          <a:ext cx="2617787" cy="228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2617200" imgH="2285280" progId="ChemDraw.Document.6.0">
                  <p:embed/>
                </p:oleObj>
              </mc:Choice>
              <mc:Fallback>
                <p:oleObj name="CS ChemDraw Drawing" r:id="rId3" imgW="2617200" imgH="2285280" progId="ChemDraw.Document.6.0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93C85394-3C10-9539-7EB6-67852DAC76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389464" y="1833292"/>
                        <a:ext cx="2617787" cy="228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BAD8290-A63E-4321-B1FE-4C90807E5B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2850223"/>
              </p:ext>
            </p:extLst>
          </p:nvPr>
        </p:nvGraphicFramePr>
        <p:xfrm>
          <a:off x="2883538" y="2114779"/>
          <a:ext cx="1469012" cy="13142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2335320" imgH="2089440" progId="ChemDraw.Document.6.0">
                  <p:embed/>
                </p:oleObj>
              </mc:Choice>
              <mc:Fallback>
                <p:oleObj name="CS ChemDraw Drawing" r:id="rId5" imgW="2335320" imgH="208944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83538" y="2114779"/>
                        <a:ext cx="1469012" cy="13142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6">
            <a:extLst>
              <a:ext uri="{FF2B5EF4-FFF2-40B4-BE49-F238E27FC236}">
                <a16:creationId xmlns:a16="http://schemas.microsoft.com/office/drawing/2014/main" id="{B9F6FD78-F837-E212-DA02-393A1EE4AC83}"/>
              </a:ext>
            </a:extLst>
          </p:cNvPr>
          <p:cNvSpPr txBox="1"/>
          <p:nvPr/>
        </p:nvSpPr>
        <p:spPr>
          <a:xfrm>
            <a:off x="1654977" y="5716654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9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19) in the positive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505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5CAE661-3F7C-9928-F7EB-71E8EC3CE54D}"/>
              </a:ext>
            </a:extLst>
          </p:cNvPr>
          <p:cNvSpPr txBox="1"/>
          <p:nvPr/>
        </p:nvSpPr>
        <p:spPr>
          <a:xfrm>
            <a:off x="3935418" y="2739355"/>
            <a:ext cx="453934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400" b="0" i="1" dirty="0">
                <a:solidFill>
                  <a:srgbClr val="1F1F1F"/>
                </a:solidFill>
                <a:effectLst/>
                <a:latin typeface="Google Sans"/>
              </a:rPr>
              <a:t>Identification of </a:t>
            </a:r>
            <a:r>
              <a:rPr lang="en-US" sz="2400" i="1" dirty="0"/>
              <a:t>Phenylpropanoids</a:t>
            </a:r>
          </a:p>
        </p:txBody>
      </p:sp>
    </p:spTree>
    <p:extLst>
      <p:ext uri="{BB962C8B-B14F-4D97-AF65-F5344CB8AC3E}">
        <p14:creationId xmlns:p14="http://schemas.microsoft.com/office/powerpoint/2010/main" val="261173084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>
            <a:extLst>
              <a:ext uri="{FF2B5EF4-FFF2-40B4-BE49-F238E27FC236}">
                <a16:creationId xmlns:a16="http://schemas.microsoft.com/office/drawing/2014/main" id="{D0C9B7F1-6147-7B8A-8F8E-0FB846BF21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4137" y="1545398"/>
            <a:ext cx="10183726" cy="3767204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84F454F7-6D6F-A136-D6F1-C7B0E271E7F6}"/>
              </a:ext>
            </a:extLst>
          </p:cNvPr>
          <p:cNvSpPr txBox="1"/>
          <p:nvPr/>
        </p:nvSpPr>
        <p:spPr>
          <a:xfrm>
            <a:off x="5292666" y="1056646"/>
            <a:ext cx="265025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Rosmarinic aci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03AFBB1-424F-4878-513A-00D811EC734D}"/>
              </a:ext>
            </a:extLst>
          </p:cNvPr>
          <p:cNvSpPr txBox="1"/>
          <p:nvPr/>
        </p:nvSpPr>
        <p:spPr>
          <a:xfrm>
            <a:off x="4544954" y="3605661"/>
            <a:ext cx="14954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affeic acid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0DD3D71D-5884-F2E8-9887-89109929FCC7}"/>
              </a:ext>
            </a:extLst>
          </p:cNvPr>
          <p:cNvCxnSpPr>
            <a:cxnSpLocks/>
          </p:cNvCxnSpPr>
          <p:nvPr/>
        </p:nvCxnSpPr>
        <p:spPr>
          <a:xfrm flipV="1">
            <a:off x="4600575" y="3888712"/>
            <a:ext cx="222634" cy="3147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7D95B999-F234-8C69-2893-4BCFEDCD99FC}"/>
              </a:ext>
            </a:extLst>
          </p:cNvPr>
          <p:cNvCxnSpPr>
            <a:cxnSpLocks/>
          </p:cNvCxnSpPr>
          <p:nvPr/>
        </p:nvCxnSpPr>
        <p:spPr>
          <a:xfrm>
            <a:off x="4005949" y="3465361"/>
            <a:ext cx="703719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849BD313-D41D-6F7C-6152-0FBBAC08D9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1352907"/>
              </p:ext>
            </p:extLst>
          </p:nvPr>
        </p:nvGraphicFramePr>
        <p:xfrm>
          <a:off x="7329656" y="1661722"/>
          <a:ext cx="3702050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3701880" imgH="1198800" progId="ChemDraw.Document.6.0">
                  <p:embed/>
                </p:oleObj>
              </mc:Choice>
              <mc:Fallback>
                <p:oleObj name="CS ChemDraw Drawing" r:id="rId4" imgW="3701880" imgH="119880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329656" y="1661722"/>
                        <a:ext cx="3702050" cy="1198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4288D05-59D2-21A0-DE24-414F24067E60}"/>
              </a:ext>
            </a:extLst>
          </p:cNvPr>
          <p:cNvSpPr txBox="1"/>
          <p:nvPr/>
        </p:nvSpPr>
        <p:spPr>
          <a:xfrm>
            <a:off x="7194510" y="2962889"/>
            <a:ext cx="1233435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 [M-198]</a:t>
            </a:r>
          </a:p>
        </p:txBody>
      </p:sp>
      <p:sp>
        <p:nvSpPr>
          <p:cNvPr id="2" name="TextBox 6">
            <a:extLst>
              <a:ext uri="{FF2B5EF4-FFF2-40B4-BE49-F238E27FC236}">
                <a16:creationId xmlns:a16="http://schemas.microsoft.com/office/drawing/2014/main" id="{86C1EC7B-AFA9-96CD-B87A-B2280D75B1E0}"/>
              </a:ext>
            </a:extLst>
          </p:cNvPr>
          <p:cNvSpPr txBox="1"/>
          <p:nvPr/>
        </p:nvSpPr>
        <p:spPr>
          <a:xfrm>
            <a:off x="1304097" y="6111714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10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30) in the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negativ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138349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8692" y="1588582"/>
            <a:ext cx="10183726" cy="3767204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77ECDF2E-8A79-D41C-3D3E-0B8AEE1183FC}"/>
              </a:ext>
            </a:extLst>
          </p:cNvPr>
          <p:cNvSpPr txBox="1"/>
          <p:nvPr/>
        </p:nvSpPr>
        <p:spPr>
          <a:xfrm>
            <a:off x="5225354" y="1188472"/>
            <a:ext cx="256192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alvianolic acid A</a:t>
            </a:r>
          </a:p>
        </p:txBody>
      </p:sp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B7B75CA8-1310-AF89-6849-61C07A7A24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6513684"/>
              </p:ext>
            </p:extLst>
          </p:nvPr>
        </p:nvGraphicFramePr>
        <p:xfrm>
          <a:off x="6966647" y="1148521"/>
          <a:ext cx="2934910" cy="18676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2392560" imgH="1523160" progId="ChemDraw.Document.6.0">
                  <p:embed/>
                </p:oleObj>
              </mc:Choice>
              <mc:Fallback>
                <p:oleObj name="CS ChemDraw Drawing" r:id="rId3" imgW="2392560" imgH="1523160" progId="ChemDraw.Document.6.0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B7B75CA8-1310-AF89-6849-61C07A7A24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66647" y="1148521"/>
                        <a:ext cx="2934910" cy="18676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C5323A71-F761-4BE3-1901-2A4C7F380C9D}"/>
              </a:ext>
            </a:extLst>
          </p:cNvPr>
          <p:cNvCxnSpPr>
            <a:cxnSpLocks/>
          </p:cNvCxnSpPr>
          <p:nvPr/>
        </p:nvCxnSpPr>
        <p:spPr>
          <a:xfrm>
            <a:off x="5816337" y="3591527"/>
            <a:ext cx="525682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09311F90-1FD0-C910-2274-9D4BF7ABA84C}"/>
              </a:ext>
            </a:extLst>
          </p:cNvPr>
          <p:cNvSpPr txBox="1"/>
          <p:nvPr/>
        </p:nvSpPr>
        <p:spPr>
          <a:xfrm>
            <a:off x="7817384" y="3125500"/>
            <a:ext cx="1233435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 [M-198]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750458E0-1575-B991-1253-8B5BD6CC5B80}"/>
              </a:ext>
            </a:extLst>
          </p:cNvPr>
          <p:cNvCxnSpPr>
            <a:cxnSpLocks/>
          </p:cNvCxnSpPr>
          <p:nvPr/>
        </p:nvCxnSpPr>
        <p:spPr>
          <a:xfrm>
            <a:off x="6265232" y="4407899"/>
            <a:ext cx="46975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4D9BA768-983B-B9A6-DE20-60D26B43BDFE}"/>
              </a:ext>
            </a:extLst>
          </p:cNvPr>
          <p:cNvSpPr txBox="1"/>
          <p:nvPr/>
        </p:nvSpPr>
        <p:spPr>
          <a:xfrm>
            <a:off x="8266279" y="3941872"/>
            <a:ext cx="1233435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 [M-180]</a:t>
            </a:r>
          </a:p>
        </p:txBody>
      </p:sp>
      <p:sp>
        <p:nvSpPr>
          <p:cNvPr id="5" name="TextBox 6">
            <a:extLst>
              <a:ext uri="{FF2B5EF4-FFF2-40B4-BE49-F238E27FC236}">
                <a16:creationId xmlns:a16="http://schemas.microsoft.com/office/drawing/2014/main" id="{286161EB-7438-AA8E-FA99-B71474C75B2C}"/>
              </a:ext>
            </a:extLst>
          </p:cNvPr>
          <p:cNvSpPr txBox="1"/>
          <p:nvPr/>
        </p:nvSpPr>
        <p:spPr>
          <a:xfrm>
            <a:off x="1824209" y="6053249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11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33) in the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negativ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567716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6453E80-9DFB-2B3E-32CB-11E681A09A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4137" y="1550689"/>
            <a:ext cx="10183726" cy="3756622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99D66287-5149-DFFC-D623-90CE05C7124A}"/>
              </a:ext>
            </a:extLst>
          </p:cNvPr>
          <p:cNvSpPr txBox="1"/>
          <p:nvPr/>
        </p:nvSpPr>
        <p:spPr>
          <a:xfrm>
            <a:off x="5502900" y="1550689"/>
            <a:ext cx="32996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alvianolic acid G</a:t>
            </a:r>
          </a:p>
        </p:txBody>
      </p:sp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A37D5B20-F6C4-1662-1E85-979511A747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9310810"/>
              </p:ext>
            </p:extLst>
          </p:nvPr>
        </p:nvGraphicFramePr>
        <p:xfrm>
          <a:off x="2943170" y="2278665"/>
          <a:ext cx="3299699" cy="1825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3124080" imgH="1728720" progId="ChemDraw.Document.6.0">
                  <p:embed/>
                </p:oleObj>
              </mc:Choice>
              <mc:Fallback>
                <p:oleObj name="CS ChemDraw Drawing" r:id="rId4" imgW="3124080" imgH="1728720" progId="ChemDraw.Document.6.0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A37D5B20-F6C4-1662-1E85-979511A747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943170" y="2278665"/>
                        <a:ext cx="3299699" cy="1825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6">
            <a:extLst>
              <a:ext uri="{FF2B5EF4-FFF2-40B4-BE49-F238E27FC236}">
                <a16:creationId xmlns:a16="http://schemas.microsoft.com/office/drawing/2014/main" id="{3D1E008B-DD0C-5DD4-20DC-E599B52AFBD4}"/>
              </a:ext>
            </a:extLst>
          </p:cNvPr>
          <p:cNvSpPr txBox="1"/>
          <p:nvPr/>
        </p:nvSpPr>
        <p:spPr>
          <a:xfrm>
            <a:off x="1801846" y="5724018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12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32) in the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negativ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12917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5CAE661-3F7C-9928-F7EB-71E8EC3CE54D}"/>
              </a:ext>
            </a:extLst>
          </p:cNvPr>
          <p:cNvSpPr txBox="1"/>
          <p:nvPr/>
        </p:nvSpPr>
        <p:spPr>
          <a:xfrm>
            <a:off x="3997562" y="3129972"/>
            <a:ext cx="578533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2400" b="0" i="1" dirty="0">
                <a:solidFill>
                  <a:srgbClr val="1F1F1F"/>
                </a:solidFill>
                <a:effectLst/>
                <a:latin typeface="Google Sans"/>
              </a:rPr>
              <a:t>Identification of </a:t>
            </a:r>
            <a:r>
              <a:rPr kumimoji="0" lang="en-US" sz="24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thospermates</a:t>
            </a:r>
          </a:p>
        </p:txBody>
      </p:sp>
    </p:spTree>
    <p:extLst>
      <p:ext uri="{BB962C8B-B14F-4D97-AF65-F5344CB8AC3E}">
        <p14:creationId xmlns:p14="http://schemas.microsoft.com/office/powerpoint/2010/main" val="84383136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6C7F87BD-9A98-9C47-257D-4ECE1870E8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566" y="1726263"/>
            <a:ext cx="10518754" cy="389113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F3661C9C-5164-02EE-D5CD-0CCBC7003575}"/>
              </a:ext>
            </a:extLst>
          </p:cNvPr>
          <p:cNvSpPr txBox="1"/>
          <p:nvPr/>
        </p:nvSpPr>
        <p:spPr>
          <a:xfrm>
            <a:off x="1282876" y="118888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Lithospermic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acid b/ Salvianolic acid B/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Monardic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acid b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E6D18C26-CC3E-08D8-CCCD-45B57682793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559675" y="904367"/>
          <a:ext cx="3260725" cy="307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3260160" imgH="3073680" progId="ChemDraw.Document.6.0">
                  <p:embed/>
                </p:oleObj>
              </mc:Choice>
              <mc:Fallback>
                <p:oleObj name="CS ChemDraw Drawing" r:id="rId4" imgW="3260160" imgH="3073680" progId="ChemDraw.Document.6.0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E6D18C26-CC3E-08D8-CCCD-45B5768279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559675" y="904367"/>
                        <a:ext cx="3260725" cy="307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061A1522-196B-638B-3D75-6D8DCE911CB5}"/>
              </a:ext>
            </a:extLst>
          </p:cNvPr>
          <p:cNvCxnSpPr>
            <a:cxnSpLocks/>
          </p:cNvCxnSpPr>
          <p:nvPr/>
        </p:nvCxnSpPr>
        <p:spPr>
          <a:xfrm>
            <a:off x="7236492" y="4612918"/>
            <a:ext cx="36961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176352C5-8E89-85F6-77EA-4F71930281E1}"/>
              </a:ext>
            </a:extLst>
          </p:cNvPr>
          <p:cNvSpPr txBox="1"/>
          <p:nvPr/>
        </p:nvSpPr>
        <p:spPr>
          <a:xfrm>
            <a:off x="7889115" y="4110446"/>
            <a:ext cx="1233435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 [M-198]</a:t>
            </a:r>
          </a:p>
        </p:txBody>
      </p:sp>
      <p:sp>
        <p:nvSpPr>
          <p:cNvPr id="4" name="TextBox 6">
            <a:extLst>
              <a:ext uri="{FF2B5EF4-FFF2-40B4-BE49-F238E27FC236}">
                <a16:creationId xmlns:a16="http://schemas.microsoft.com/office/drawing/2014/main" id="{BC05EE48-9335-5F73-22A5-4E410E18C787}"/>
              </a:ext>
            </a:extLst>
          </p:cNvPr>
          <p:cNvSpPr txBox="1"/>
          <p:nvPr/>
        </p:nvSpPr>
        <p:spPr>
          <a:xfrm>
            <a:off x="1776370" y="5768967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13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34) in the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negativ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719943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>
            <a:extLst>
              <a:ext uri="{FF2B5EF4-FFF2-40B4-BE49-F238E27FC236}">
                <a16:creationId xmlns:a16="http://schemas.microsoft.com/office/drawing/2014/main" id="{F113D435-702F-F79C-EB02-0A0D717CB8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3025" y="1967429"/>
            <a:ext cx="10183726" cy="376720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0C69F4A-05C6-9132-1604-28281736BCB0}"/>
              </a:ext>
            </a:extLst>
          </p:cNvPr>
          <p:cNvSpPr txBox="1"/>
          <p:nvPr/>
        </p:nvSpPr>
        <p:spPr>
          <a:xfrm>
            <a:off x="4131076" y="1567319"/>
            <a:ext cx="275258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Methyl </a:t>
            </a:r>
            <a:r>
              <a:rPr kumimoji="0" lang="en-US" sz="2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lithospermate</a:t>
            </a:r>
            <a:endParaRPr kumimoji="0" 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E10FD9A-2D77-C6A3-749C-6BBBEAF415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1337092"/>
              </p:ext>
            </p:extLst>
          </p:nvPr>
        </p:nvGraphicFramePr>
        <p:xfrm>
          <a:off x="6310906" y="1406545"/>
          <a:ext cx="3084302" cy="17983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3861360" imgH="2251800" progId="ChemDraw.Document.6.0">
                  <p:embed/>
                </p:oleObj>
              </mc:Choice>
              <mc:Fallback>
                <p:oleObj name="CS ChemDraw Drawing" r:id="rId4" imgW="3861360" imgH="225180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310906" y="1406545"/>
                        <a:ext cx="3084302" cy="17983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CC52B720-B97F-5D8F-E20E-5F5F4A6EE43F}"/>
              </a:ext>
            </a:extLst>
          </p:cNvPr>
          <p:cNvCxnSpPr>
            <a:cxnSpLocks/>
          </p:cNvCxnSpPr>
          <p:nvPr/>
        </p:nvCxnSpPr>
        <p:spPr>
          <a:xfrm>
            <a:off x="9829859" y="4539061"/>
            <a:ext cx="94719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B6E254B2-8BD6-AD91-00A8-E5A0D5E4CB7E}"/>
              </a:ext>
            </a:extLst>
          </p:cNvPr>
          <p:cNvSpPr txBox="1"/>
          <p:nvPr/>
        </p:nvSpPr>
        <p:spPr>
          <a:xfrm>
            <a:off x="9829859" y="3960053"/>
            <a:ext cx="860366" cy="369332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-32</a:t>
            </a:r>
          </a:p>
        </p:txBody>
      </p:sp>
      <p:sp>
        <p:nvSpPr>
          <p:cNvPr id="5" name="TextBox 6">
            <a:extLst>
              <a:ext uri="{FF2B5EF4-FFF2-40B4-BE49-F238E27FC236}">
                <a16:creationId xmlns:a16="http://schemas.microsoft.com/office/drawing/2014/main" id="{46E4ED48-32D1-CC87-FC38-DBE702581E4A}"/>
              </a:ext>
            </a:extLst>
          </p:cNvPr>
          <p:cNvSpPr txBox="1"/>
          <p:nvPr/>
        </p:nvSpPr>
        <p:spPr>
          <a:xfrm>
            <a:off x="1525161" y="5793717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14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39) in the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negativ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8466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352D57C7-492B-52FC-B489-F5F60E082219}"/>
              </a:ext>
            </a:extLst>
          </p:cNvPr>
          <p:cNvSpPr txBox="1"/>
          <p:nvPr/>
        </p:nvSpPr>
        <p:spPr>
          <a:xfrm>
            <a:off x="3976097" y="1552326"/>
            <a:ext cx="35874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imethyl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lithospermate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5EBD7310-80F8-B6A0-2516-0181EC868F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2659" y="2135948"/>
            <a:ext cx="10711404" cy="3767204"/>
          </a:xfrm>
          <a:prstGeom prst="rect">
            <a:avLst/>
          </a:prstGeom>
        </p:spPr>
      </p:pic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6B4EE679-AE8C-DCF1-DC84-88C2F39C5787}"/>
              </a:ext>
            </a:extLst>
          </p:cNvPr>
          <p:cNvCxnSpPr>
            <a:cxnSpLocks/>
          </p:cNvCxnSpPr>
          <p:nvPr/>
        </p:nvCxnSpPr>
        <p:spPr>
          <a:xfrm>
            <a:off x="9662644" y="4518963"/>
            <a:ext cx="142069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ABE03DD8-18F2-7810-7FD7-1C692153CC39}"/>
              </a:ext>
            </a:extLst>
          </p:cNvPr>
          <p:cNvSpPr txBox="1"/>
          <p:nvPr/>
        </p:nvSpPr>
        <p:spPr>
          <a:xfrm>
            <a:off x="9743028" y="3905716"/>
            <a:ext cx="1126892" cy="369332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-31-17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293561B8-5B94-9C7B-FDF9-82749D8B88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2377811"/>
              </p:ext>
            </p:extLst>
          </p:nvPr>
        </p:nvGraphicFramePr>
        <p:xfrm>
          <a:off x="6343650" y="1122418"/>
          <a:ext cx="4346575" cy="220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4347360" imgH="2204280" progId="ChemDraw.Document.6.0">
                  <p:embed/>
                </p:oleObj>
              </mc:Choice>
              <mc:Fallback>
                <p:oleObj name="CS ChemDraw Drawing" r:id="rId3" imgW="4347360" imgH="2204280" progId="ChemDraw.Document.6.0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293561B8-5B94-9C7B-FDF9-82749D8B88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43650" y="1122418"/>
                        <a:ext cx="4346575" cy="220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6">
            <a:extLst>
              <a:ext uri="{FF2B5EF4-FFF2-40B4-BE49-F238E27FC236}">
                <a16:creationId xmlns:a16="http://schemas.microsoft.com/office/drawing/2014/main" id="{F86BCDB4-9B74-5B03-3FDA-A3C130BE2DD2}"/>
              </a:ext>
            </a:extLst>
          </p:cNvPr>
          <p:cNvSpPr txBox="1"/>
          <p:nvPr/>
        </p:nvSpPr>
        <p:spPr>
          <a:xfrm>
            <a:off x="1451225" y="5962401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15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41) in the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negativ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899547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78FF88C-9091-BEAE-7415-09D3C0823307}"/>
              </a:ext>
            </a:extLst>
          </p:cNvPr>
          <p:cNvSpPr txBox="1"/>
          <p:nvPr/>
        </p:nvSpPr>
        <p:spPr>
          <a:xfrm>
            <a:off x="4201749" y="3429000"/>
            <a:ext cx="453934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400" b="0" i="1" dirty="0">
                <a:solidFill>
                  <a:srgbClr val="1F1F1F"/>
                </a:solidFill>
                <a:effectLst/>
                <a:latin typeface="Google Sans"/>
              </a:rPr>
              <a:t>Identification of </a:t>
            </a:r>
            <a:r>
              <a:rPr lang="en-US" sz="2400" i="1" dirty="0"/>
              <a:t>Fatty acids</a:t>
            </a:r>
          </a:p>
        </p:txBody>
      </p:sp>
    </p:spTree>
    <p:extLst>
      <p:ext uri="{BB962C8B-B14F-4D97-AF65-F5344CB8AC3E}">
        <p14:creationId xmlns:p14="http://schemas.microsoft.com/office/powerpoint/2010/main" val="1359835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5CAE661-3F7C-9928-F7EB-71E8EC3CE54D}"/>
              </a:ext>
            </a:extLst>
          </p:cNvPr>
          <p:cNvSpPr txBox="1"/>
          <p:nvPr/>
        </p:nvSpPr>
        <p:spPr>
          <a:xfrm>
            <a:off x="3795546" y="2640197"/>
            <a:ext cx="628775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400" b="0" i="1" dirty="0">
                <a:solidFill>
                  <a:srgbClr val="1F1F1F"/>
                </a:solidFill>
                <a:effectLst/>
                <a:latin typeface="Google Sans"/>
              </a:rPr>
              <a:t>Identification of Pyrrolizidine alkaloids (PAs)</a:t>
            </a:r>
            <a:endParaRPr lang="en-US" sz="2400" i="1" dirty="0"/>
          </a:p>
        </p:txBody>
      </p:sp>
    </p:spTree>
    <p:extLst>
      <p:ext uri="{BB962C8B-B14F-4D97-AF65-F5344CB8AC3E}">
        <p14:creationId xmlns:p14="http://schemas.microsoft.com/office/powerpoint/2010/main" val="263047144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4137" y="1550689"/>
            <a:ext cx="10183726" cy="431754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199EEDA-8523-A4F0-BF6A-8CB6D5D054CE}"/>
              </a:ext>
            </a:extLst>
          </p:cNvPr>
          <p:cNvSpPr txBox="1"/>
          <p:nvPr/>
        </p:nvSpPr>
        <p:spPr>
          <a:xfrm>
            <a:off x="5395267" y="1550689"/>
            <a:ext cx="28827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6-henicosyloxan-2-one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BC5D26E3-1F1C-0B23-5C81-AA034F63222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45369" y="2495550"/>
          <a:ext cx="6282670" cy="758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3903120" imgH="471960" progId="ChemDraw.Document.6.0">
                  <p:embed/>
                </p:oleObj>
              </mc:Choice>
              <mc:Fallback>
                <p:oleObj name="CS ChemDraw Drawing" r:id="rId3" imgW="3903120" imgH="471960" progId="ChemDraw.Document.6.0">
                  <p:embed/>
                  <p:pic>
                    <p:nvPicPr>
                      <p:cNvPr id="35" name="Object 34">
                        <a:extLst>
                          <a:ext uri="{FF2B5EF4-FFF2-40B4-BE49-F238E27FC236}">
                            <a16:creationId xmlns:a16="http://schemas.microsoft.com/office/drawing/2014/main" id="{FD1DB4B6-866E-3D39-2DD4-6DB6EC4702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45369" y="2495550"/>
                        <a:ext cx="6282670" cy="758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6">
            <a:extLst>
              <a:ext uri="{FF2B5EF4-FFF2-40B4-BE49-F238E27FC236}">
                <a16:creationId xmlns:a16="http://schemas.microsoft.com/office/drawing/2014/main" id="{2087E9D5-C109-825D-8137-5D161E38A2CF}"/>
              </a:ext>
            </a:extLst>
          </p:cNvPr>
          <p:cNvSpPr txBox="1"/>
          <p:nvPr/>
        </p:nvSpPr>
        <p:spPr>
          <a:xfrm>
            <a:off x="1304097" y="6111714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16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86) in the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positiv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2F3056E2-357E-8EF1-5331-A1D448F1FD51}"/>
              </a:ext>
            </a:extLst>
          </p:cNvPr>
          <p:cNvCxnSpPr>
            <a:cxnSpLocks/>
          </p:cNvCxnSpPr>
          <p:nvPr/>
        </p:nvCxnSpPr>
        <p:spPr>
          <a:xfrm>
            <a:off x="10010731" y="4388334"/>
            <a:ext cx="9445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50A17362-0E80-9130-4B48-30DCC0B0B44B}"/>
              </a:ext>
            </a:extLst>
          </p:cNvPr>
          <p:cNvSpPr txBox="1"/>
          <p:nvPr/>
        </p:nvSpPr>
        <p:spPr>
          <a:xfrm>
            <a:off x="10060971" y="3775087"/>
            <a:ext cx="881684" cy="369332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-18</a:t>
            </a:r>
          </a:p>
        </p:txBody>
      </p:sp>
    </p:spTree>
    <p:extLst>
      <p:ext uri="{BB962C8B-B14F-4D97-AF65-F5344CB8AC3E}">
        <p14:creationId xmlns:p14="http://schemas.microsoft.com/office/powerpoint/2010/main" val="103845601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4137" y="1550689"/>
            <a:ext cx="10183726" cy="3756622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2940A6DD-BAB9-0C0C-AEB9-C87945A12B6B}"/>
              </a:ext>
            </a:extLst>
          </p:cNvPr>
          <p:cNvSpPr txBox="1"/>
          <p:nvPr/>
        </p:nvSpPr>
        <p:spPr>
          <a:xfrm>
            <a:off x="5362668" y="1495541"/>
            <a:ext cx="323872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6-docosyloxan-2-one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848B77C-20E2-8ED1-BD7E-9D5A4035AA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6252091"/>
              </p:ext>
            </p:extLst>
          </p:nvPr>
        </p:nvGraphicFramePr>
        <p:xfrm>
          <a:off x="2371411" y="2235093"/>
          <a:ext cx="6940708" cy="8058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4060800" imgH="471960" progId="ChemDraw.Document.6.0">
                  <p:embed/>
                </p:oleObj>
              </mc:Choice>
              <mc:Fallback>
                <p:oleObj name="CS ChemDraw Drawing" r:id="rId4" imgW="4060800" imgH="47196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371411" y="2235093"/>
                        <a:ext cx="6940708" cy="8058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6">
            <a:extLst>
              <a:ext uri="{FF2B5EF4-FFF2-40B4-BE49-F238E27FC236}">
                <a16:creationId xmlns:a16="http://schemas.microsoft.com/office/drawing/2014/main" id="{D78917CB-D1A8-4286-27D0-03A1E5061A22}"/>
              </a:ext>
            </a:extLst>
          </p:cNvPr>
          <p:cNvSpPr txBox="1"/>
          <p:nvPr/>
        </p:nvSpPr>
        <p:spPr>
          <a:xfrm>
            <a:off x="1927095" y="5622383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17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85) in the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positiv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524409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78FF88C-9091-BEAE-7415-09D3C0823307}"/>
              </a:ext>
            </a:extLst>
          </p:cNvPr>
          <p:cNvSpPr txBox="1"/>
          <p:nvPr/>
        </p:nvSpPr>
        <p:spPr>
          <a:xfrm>
            <a:off x="4299402" y="2801499"/>
            <a:ext cx="453934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400" b="0" i="1" dirty="0">
                <a:solidFill>
                  <a:srgbClr val="1F1F1F"/>
                </a:solidFill>
                <a:effectLst/>
                <a:latin typeface="Google Sans"/>
              </a:rPr>
              <a:t>Identification of </a:t>
            </a:r>
            <a:r>
              <a:rPr lang="en-US" sz="2400" i="1" dirty="0"/>
              <a:t>Fatty acid amides</a:t>
            </a:r>
          </a:p>
        </p:txBody>
      </p:sp>
    </p:spTree>
    <p:extLst>
      <p:ext uri="{BB962C8B-B14F-4D97-AF65-F5344CB8AC3E}">
        <p14:creationId xmlns:p14="http://schemas.microsoft.com/office/powerpoint/2010/main" val="21335986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4137" y="1550689"/>
            <a:ext cx="10183726" cy="375662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6A91331-9D9E-DDF8-6D29-33357D1AC91B}"/>
              </a:ext>
            </a:extLst>
          </p:cNvPr>
          <p:cNvSpPr txBox="1"/>
          <p:nvPr/>
        </p:nvSpPr>
        <p:spPr>
          <a:xfrm>
            <a:off x="6363119" y="1822737"/>
            <a:ext cx="169817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noleamide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F899530A-2BAC-2A34-DAFF-8C549AFB5B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6220173"/>
              </p:ext>
            </p:extLst>
          </p:nvPr>
        </p:nvGraphicFramePr>
        <p:xfrm>
          <a:off x="4014788" y="3202781"/>
          <a:ext cx="3095625" cy="452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3095280" imgH="452160" progId="ChemDraw.Document.6.0">
                  <p:embed/>
                </p:oleObj>
              </mc:Choice>
              <mc:Fallback>
                <p:oleObj name="CS ChemDraw Drawing" r:id="rId4" imgW="3095280" imgH="452160" progId="ChemDraw.Document.6.0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F899530A-2BAC-2A34-DAFF-8C549AFB5B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014788" y="3202781"/>
                        <a:ext cx="3095625" cy="452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6">
            <a:extLst>
              <a:ext uri="{FF2B5EF4-FFF2-40B4-BE49-F238E27FC236}">
                <a16:creationId xmlns:a16="http://schemas.microsoft.com/office/drawing/2014/main" id="{95B8CE90-7356-8186-0CFC-5EDB8F412564}"/>
              </a:ext>
            </a:extLst>
          </p:cNvPr>
          <p:cNvSpPr txBox="1"/>
          <p:nvPr/>
        </p:nvSpPr>
        <p:spPr>
          <a:xfrm>
            <a:off x="2107965" y="5443335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18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63) in the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positiv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8B80B58D-ECC6-2CF2-135B-F19894BD0C67}"/>
              </a:ext>
            </a:extLst>
          </p:cNvPr>
          <p:cNvCxnSpPr>
            <a:cxnSpLocks/>
          </p:cNvCxnSpPr>
          <p:nvPr/>
        </p:nvCxnSpPr>
        <p:spPr>
          <a:xfrm>
            <a:off x="9749474" y="3355993"/>
            <a:ext cx="124053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50E61B78-1B16-23BA-B86A-54094FE26A6A}"/>
              </a:ext>
            </a:extLst>
          </p:cNvPr>
          <p:cNvSpPr txBox="1"/>
          <p:nvPr/>
        </p:nvSpPr>
        <p:spPr>
          <a:xfrm>
            <a:off x="9799714" y="2742746"/>
            <a:ext cx="881684" cy="369332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-17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AEF26557-455F-BAA2-D607-EBB3D2697320}"/>
              </a:ext>
            </a:extLst>
          </p:cNvPr>
          <p:cNvCxnSpPr>
            <a:cxnSpLocks/>
          </p:cNvCxnSpPr>
          <p:nvPr/>
        </p:nvCxnSpPr>
        <p:spPr>
          <a:xfrm>
            <a:off x="8931353" y="4384294"/>
            <a:ext cx="205865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96D3E8CD-AB19-A179-0033-51104AF3319A}"/>
              </a:ext>
            </a:extLst>
          </p:cNvPr>
          <p:cNvSpPr txBox="1"/>
          <p:nvPr/>
        </p:nvSpPr>
        <p:spPr>
          <a:xfrm>
            <a:off x="9741999" y="3811240"/>
            <a:ext cx="1150414" cy="369332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-17-18</a:t>
            </a:r>
          </a:p>
        </p:txBody>
      </p:sp>
    </p:spTree>
    <p:extLst>
      <p:ext uri="{BB962C8B-B14F-4D97-AF65-F5344CB8AC3E}">
        <p14:creationId xmlns:p14="http://schemas.microsoft.com/office/powerpoint/2010/main" val="193470731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4137" y="1550689"/>
            <a:ext cx="10183726" cy="3756622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35FF3160-0FD8-0D16-8302-28C7EA441239}"/>
              </a:ext>
            </a:extLst>
          </p:cNvPr>
          <p:cNvSpPr txBox="1"/>
          <p:nvPr/>
        </p:nvSpPr>
        <p:spPr>
          <a:xfrm>
            <a:off x="6235002" y="1366023"/>
            <a:ext cx="14804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Oleamide</a:t>
            </a: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4C93E85A-3DBF-6F16-B7CF-48B30F6414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3744099"/>
              </p:ext>
            </p:extLst>
          </p:nvPr>
        </p:nvGraphicFramePr>
        <p:xfrm>
          <a:off x="3357458" y="2577316"/>
          <a:ext cx="4435092" cy="6482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3095280" imgH="452160" progId="ChemDraw.Document.6.0">
                  <p:embed/>
                </p:oleObj>
              </mc:Choice>
              <mc:Fallback>
                <p:oleObj name="CS ChemDraw Drawing" r:id="rId3" imgW="3095280" imgH="452160" progId="ChemDraw.Document.6.0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4C93E85A-3DBF-6F16-B7CF-48B30F6414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57458" y="2577316"/>
                        <a:ext cx="4435092" cy="6482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6">
            <a:extLst>
              <a:ext uri="{FF2B5EF4-FFF2-40B4-BE49-F238E27FC236}">
                <a16:creationId xmlns:a16="http://schemas.microsoft.com/office/drawing/2014/main" id="{3CA7856B-3EB0-2CA3-9490-C6D8488DE537}"/>
              </a:ext>
            </a:extLst>
          </p:cNvPr>
          <p:cNvSpPr txBox="1"/>
          <p:nvPr/>
        </p:nvSpPr>
        <p:spPr>
          <a:xfrm>
            <a:off x="1793979" y="5579151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19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68) in the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positiv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E027724A-034F-FCB9-FDAB-98138E17DF6D}"/>
              </a:ext>
            </a:extLst>
          </p:cNvPr>
          <p:cNvCxnSpPr>
            <a:cxnSpLocks/>
          </p:cNvCxnSpPr>
          <p:nvPr/>
        </p:nvCxnSpPr>
        <p:spPr>
          <a:xfrm>
            <a:off x="9799714" y="3343309"/>
            <a:ext cx="124053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FA9D72D2-94D6-809A-CF84-B10272B32939}"/>
              </a:ext>
            </a:extLst>
          </p:cNvPr>
          <p:cNvSpPr txBox="1"/>
          <p:nvPr/>
        </p:nvSpPr>
        <p:spPr>
          <a:xfrm>
            <a:off x="9849954" y="2730062"/>
            <a:ext cx="881684" cy="369332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-17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A9DFF0CF-822D-AA64-0F2D-528E4C1500DE}"/>
              </a:ext>
            </a:extLst>
          </p:cNvPr>
          <p:cNvCxnSpPr>
            <a:cxnSpLocks/>
          </p:cNvCxnSpPr>
          <p:nvPr/>
        </p:nvCxnSpPr>
        <p:spPr>
          <a:xfrm>
            <a:off x="9092124" y="4384294"/>
            <a:ext cx="205865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B560502C-A19A-005F-806E-258FCB4B5901}"/>
              </a:ext>
            </a:extLst>
          </p:cNvPr>
          <p:cNvSpPr txBox="1"/>
          <p:nvPr/>
        </p:nvSpPr>
        <p:spPr>
          <a:xfrm>
            <a:off x="9902770" y="3811240"/>
            <a:ext cx="1150414" cy="369332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-17-18</a:t>
            </a:r>
          </a:p>
        </p:txBody>
      </p:sp>
    </p:spTree>
    <p:extLst>
      <p:ext uri="{BB962C8B-B14F-4D97-AF65-F5344CB8AC3E}">
        <p14:creationId xmlns:p14="http://schemas.microsoft.com/office/powerpoint/2010/main" val="134531717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4137" y="1550689"/>
            <a:ext cx="10183726" cy="375662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2BF5C78-974F-5D9E-05F0-EB6039D6EC66}"/>
              </a:ext>
            </a:extLst>
          </p:cNvPr>
          <p:cNvSpPr txBox="1"/>
          <p:nvPr/>
        </p:nvSpPr>
        <p:spPr>
          <a:xfrm>
            <a:off x="5042987" y="1727864"/>
            <a:ext cx="33737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Docosenamid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9877028-A77E-C53E-A89A-1614FB838E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7273244"/>
              </p:ext>
            </p:extLst>
          </p:nvPr>
        </p:nvGraphicFramePr>
        <p:xfrm>
          <a:off x="3460817" y="2508128"/>
          <a:ext cx="4666223" cy="5661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3728520" imgH="452160" progId="ChemDraw.Document.6.0">
                  <p:embed/>
                </p:oleObj>
              </mc:Choice>
              <mc:Fallback>
                <p:oleObj name="CS ChemDraw Drawing" r:id="rId3" imgW="3728520" imgH="452160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69877028-A77E-C53E-A89A-1614FB838E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60817" y="2508128"/>
                        <a:ext cx="4666223" cy="5661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6">
            <a:extLst>
              <a:ext uri="{FF2B5EF4-FFF2-40B4-BE49-F238E27FC236}">
                <a16:creationId xmlns:a16="http://schemas.microsoft.com/office/drawing/2014/main" id="{32F13433-4249-D09F-6AAA-1FE28DAC041C}"/>
              </a:ext>
            </a:extLst>
          </p:cNvPr>
          <p:cNvSpPr txBox="1"/>
          <p:nvPr/>
        </p:nvSpPr>
        <p:spPr>
          <a:xfrm>
            <a:off x="1793979" y="5579151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20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79) in the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positiv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E36F5101-F31B-96C2-B302-84B625A5B403}"/>
              </a:ext>
            </a:extLst>
          </p:cNvPr>
          <p:cNvCxnSpPr>
            <a:cxnSpLocks/>
          </p:cNvCxnSpPr>
          <p:nvPr/>
        </p:nvCxnSpPr>
        <p:spPr>
          <a:xfrm>
            <a:off x="9947327" y="3684949"/>
            <a:ext cx="124053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C779C935-8157-CF82-978B-094A0681D8F9}"/>
              </a:ext>
            </a:extLst>
          </p:cNvPr>
          <p:cNvSpPr txBox="1"/>
          <p:nvPr/>
        </p:nvSpPr>
        <p:spPr>
          <a:xfrm>
            <a:off x="10111209" y="3212379"/>
            <a:ext cx="881684" cy="369332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-17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A6A8F88-0382-F671-B0CF-84B6906187B7}"/>
              </a:ext>
            </a:extLst>
          </p:cNvPr>
          <p:cNvCxnSpPr>
            <a:cxnSpLocks/>
          </p:cNvCxnSpPr>
          <p:nvPr/>
        </p:nvCxnSpPr>
        <p:spPr>
          <a:xfrm>
            <a:off x="9373480" y="4515186"/>
            <a:ext cx="205865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66D8907D-6815-F1B0-3E69-07B4A01C8A07}"/>
              </a:ext>
            </a:extLst>
          </p:cNvPr>
          <p:cNvSpPr txBox="1"/>
          <p:nvPr/>
        </p:nvSpPr>
        <p:spPr>
          <a:xfrm>
            <a:off x="10037449" y="3956790"/>
            <a:ext cx="1150414" cy="369332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-17-18</a:t>
            </a:r>
          </a:p>
        </p:txBody>
      </p:sp>
    </p:spTree>
    <p:extLst>
      <p:ext uri="{BB962C8B-B14F-4D97-AF65-F5344CB8AC3E}">
        <p14:creationId xmlns:p14="http://schemas.microsoft.com/office/powerpoint/2010/main" val="171980674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4137" y="1550689"/>
            <a:ext cx="10183726" cy="375662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92B6302-18B2-2368-3DE8-47AA362399F5}"/>
              </a:ext>
            </a:extLst>
          </p:cNvPr>
          <p:cNvSpPr txBox="1"/>
          <p:nvPr/>
        </p:nvSpPr>
        <p:spPr>
          <a:xfrm>
            <a:off x="4751351" y="1764618"/>
            <a:ext cx="41752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Tetracosenamid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 (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Nervonamid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+mn-cs"/>
              </a:rPr>
              <a:t>)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68B34334-6473-9CC4-13C8-530822D711C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75354" y="2347878"/>
          <a:ext cx="6139560" cy="6867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4044960" imgH="452160" progId="ChemDraw.Document.6.0">
                  <p:embed/>
                </p:oleObj>
              </mc:Choice>
              <mc:Fallback>
                <p:oleObj name="CS ChemDraw Drawing" r:id="rId3" imgW="4044960" imgH="452160" progId="ChemDraw.Document.6.0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68B34334-6473-9CC4-13C8-530822D711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75354" y="2347878"/>
                        <a:ext cx="6139560" cy="6867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6">
            <a:extLst>
              <a:ext uri="{FF2B5EF4-FFF2-40B4-BE49-F238E27FC236}">
                <a16:creationId xmlns:a16="http://schemas.microsoft.com/office/drawing/2014/main" id="{404F4A6F-FFDE-98D9-8BC8-EC680EFA5A06}"/>
              </a:ext>
            </a:extLst>
          </p:cNvPr>
          <p:cNvSpPr txBox="1"/>
          <p:nvPr/>
        </p:nvSpPr>
        <p:spPr>
          <a:xfrm>
            <a:off x="1793979" y="5579151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</a:t>
            </a: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21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81) in the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positiv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51CC02D5-9C02-B326-CE5C-5664F60B8A14}"/>
              </a:ext>
            </a:extLst>
          </p:cNvPr>
          <p:cNvCxnSpPr>
            <a:cxnSpLocks/>
          </p:cNvCxnSpPr>
          <p:nvPr/>
        </p:nvCxnSpPr>
        <p:spPr>
          <a:xfrm>
            <a:off x="10040869" y="3745240"/>
            <a:ext cx="931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3D8290DE-452C-A511-642C-A2707940A04C}"/>
              </a:ext>
            </a:extLst>
          </p:cNvPr>
          <p:cNvSpPr txBox="1"/>
          <p:nvPr/>
        </p:nvSpPr>
        <p:spPr>
          <a:xfrm>
            <a:off x="10091109" y="3222428"/>
            <a:ext cx="881684" cy="369332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-17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7992FE7-70DB-8528-CF32-1D382C4950AD}"/>
              </a:ext>
            </a:extLst>
          </p:cNvPr>
          <p:cNvCxnSpPr>
            <a:cxnSpLocks/>
          </p:cNvCxnSpPr>
          <p:nvPr/>
        </p:nvCxnSpPr>
        <p:spPr>
          <a:xfrm>
            <a:off x="9403625" y="4550664"/>
            <a:ext cx="178423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4ECECC74-E1D5-0EE0-ECC8-97EA27DD0147}"/>
              </a:ext>
            </a:extLst>
          </p:cNvPr>
          <p:cNvSpPr txBox="1"/>
          <p:nvPr/>
        </p:nvSpPr>
        <p:spPr>
          <a:xfrm>
            <a:off x="10040869" y="4094158"/>
            <a:ext cx="1150414" cy="369332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-17-18</a:t>
            </a:r>
          </a:p>
        </p:txBody>
      </p:sp>
    </p:spTree>
    <p:extLst>
      <p:ext uri="{BB962C8B-B14F-4D97-AF65-F5344CB8AC3E}">
        <p14:creationId xmlns:p14="http://schemas.microsoft.com/office/powerpoint/2010/main" val="38086916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7269F80B-98BF-0018-DB68-F4E5430CE1B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6692" b="20494"/>
          <a:stretch/>
        </p:blipFill>
        <p:spPr>
          <a:xfrm>
            <a:off x="725446" y="1503458"/>
            <a:ext cx="10156919" cy="440497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CD28A4C-8230-D0DE-F98B-7E981A3B58D6}"/>
              </a:ext>
            </a:extLst>
          </p:cNvPr>
          <p:cNvSpPr txBox="1"/>
          <p:nvPr/>
        </p:nvSpPr>
        <p:spPr>
          <a:xfrm>
            <a:off x="4171967" y="1973175"/>
            <a:ext cx="55517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ea typeface="+mn-ea"/>
                <a:cs typeface="+mn-cs"/>
              </a:rPr>
              <a:t>Lycopsamine</a:t>
            </a:r>
            <a:r>
              <a:rPr kumimoji="0" lang="en-US" sz="18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+mn-ea"/>
                <a:cs typeface="+mn-cs"/>
              </a:rPr>
              <a:t> (9-Viridiflorylretronecine)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53D04392-5EED-9731-2BEE-185E85C64D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44492"/>
              </p:ext>
            </p:extLst>
          </p:nvPr>
        </p:nvGraphicFramePr>
        <p:xfrm>
          <a:off x="8099286" y="1649667"/>
          <a:ext cx="2686050" cy="2009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2042280" imgH="1531800" progId="ChemDraw.Document.6.0">
                  <p:embed/>
                </p:oleObj>
              </mc:Choice>
              <mc:Fallback>
                <p:oleObj name="CS ChemDraw Drawing" r:id="rId4" imgW="2042280" imgH="153180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099286" y="1649667"/>
                        <a:ext cx="2686050" cy="2009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ABF84018-5176-DF9C-A8E2-C87DCFB570C7}"/>
              </a:ext>
            </a:extLst>
          </p:cNvPr>
          <p:cNvCxnSpPr>
            <a:cxnSpLocks/>
          </p:cNvCxnSpPr>
          <p:nvPr/>
        </p:nvCxnSpPr>
        <p:spPr>
          <a:xfrm>
            <a:off x="3754121" y="3940803"/>
            <a:ext cx="63874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0F8F252E-77B3-6DB0-4CBB-CB1EE9106D6C}"/>
              </a:ext>
            </a:extLst>
          </p:cNvPr>
          <p:cNvSpPr txBox="1"/>
          <p:nvPr/>
        </p:nvSpPr>
        <p:spPr>
          <a:xfrm>
            <a:off x="5745120" y="3474776"/>
            <a:ext cx="1233435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 [M-162]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D09B3142-0B28-CBE8-8261-1ECA3E21B8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3938208"/>
              </p:ext>
            </p:extLst>
          </p:nvPr>
        </p:nvGraphicFramePr>
        <p:xfrm>
          <a:off x="2319709" y="2256375"/>
          <a:ext cx="1282700" cy="90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1282320" imgH="905760" progId="ChemDraw.Document.6.0">
                  <p:embed/>
                </p:oleObj>
              </mc:Choice>
              <mc:Fallback>
                <p:oleObj name="CS ChemDraw Drawing" r:id="rId6" imgW="1282320" imgH="90576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319709" y="2256375"/>
                        <a:ext cx="1282700" cy="90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5D8BE9A0-5F25-8F4D-37A8-71F2BCF1A70C}"/>
              </a:ext>
            </a:extLst>
          </p:cNvPr>
          <p:cNvCxnSpPr/>
          <p:nvPr/>
        </p:nvCxnSpPr>
        <p:spPr>
          <a:xfrm flipV="1">
            <a:off x="4391130" y="4772967"/>
            <a:ext cx="452175" cy="29140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040E4C05-8758-1EB9-7112-FBF1539225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5111669"/>
              </p:ext>
            </p:extLst>
          </p:nvPr>
        </p:nvGraphicFramePr>
        <p:xfrm>
          <a:off x="4545018" y="4038557"/>
          <a:ext cx="1258887" cy="1306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8" imgW="1259640" imgH="1306800" progId="ChemDraw.Document.6.0">
                  <p:embed/>
                </p:oleObj>
              </mc:Choice>
              <mc:Fallback>
                <p:oleObj name="CS ChemDraw Drawing" r:id="rId8" imgW="1259640" imgH="130680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545018" y="4038557"/>
                        <a:ext cx="1258887" cy="1306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6">
            <a:extLst>
              <a:ext uri="{FF2B5EF4-FFF2-40B4-BE49-F238E27FC236}">
                <a16:creationId xmlns:a16="http://schemas.microsoft.com/office/drawing/2014/main" id="{BF879BF6-2BF7-44A4-BD61-FC0D150ED505}"/>
              </a:ext>
            </a:extLst>
          </p:cNvPr>
          <p:cNvSpPr txBox="1"/>
          <p:nvPr/>
        </p:nvSpPr>
        <p:spPr>
          <a:xfrm>
            <a:off x="1304097" y="6111714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2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5) in the positive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36296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44F3296E-F4B5-17FF-8F8C-2F0D40770F5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0603" b="18025"/>
          <a:stretch/>
        </p:blipFill>
        <p:spPr>
          <a:xfrm>
            <a:off x="200966" y="1225899"/>
            <a:ext cx="11208561" cy="4696225"/>
          </a:xfrm>
          <a:prstGeom prst="rect">
            <a:avLst/>
          </a:prstGeom>
        </p:spPr>
      </p:pic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0194515"/>
              </p:ext>
            </p:extLst>
          </p:nvPr>
        </p:nvGraphicFramePr>
        <p:xfrm>
          <a:off x="7570549" y="2095342"/>
          <a:ext cx="2538976" cy="20328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3060000" imgH="2451240" progId="ChemDraw.Document.6.0">
                  <p:embed/>
                </p:oleObj>
              </mc:Choice>
              <mc:Fallback>
                <p:oleObj name="CS ChemDraw Drawing" r:id="rId4" imgW="3060000" imgH="2451240" progId="ChemDraw.Document.6.0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570549" y="2095342"/>
                        <a:ext cx="2538976" cy="20328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4E0A7C86-2596-8017-5DC0-21F72EEECA46}"/>
              </a:ext>
            </a:extLst>
          </p:cNvPr>
          <p:cNvSpPr txBox="1"/>
          <p:nvPr/>
        </p:nvSpPr>
        <p:spPr>
          <a:xfrm>
            <a:off x="5255286" y="1446333"/>
            <a:ext cx="405953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ycopsamine</a:t>
            </a:r>
            <a:r>
              <a:rPr lang="en-US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ermedine</a:t>
            </a:r>
            <a:r>
              <a:rPr lang="en-US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-</a:t>
            </a:r>
            <a:r>
              <a:rPr lang="en-US" sz="18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oxide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103D428D-2CF4-F65E-BB03-1594859101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967335"/>
              </p:ext>
            </p:extLst>
          </p:nvPr>
        </p:nvGraphicFramePr>
        <p:xfrm>
          <a:off x="3254134" y="1659941"/>
          <a:ext cx="1343025" cy="1376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1342440" imgH="1375920" progId="ChemDraw.Document.6.0">
                  <p:embed/>
                </p:oleObj>
              </mc:Choice>
              <mc:Fallback>
                <p:oleObj name="CS ChemDraw Drawing" r:id="rId6" imgW="1342440" imgH="137592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254134" y="1659941"/>
                        <a:ext cx="1343025" cy="1376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6">
            <a:extLst>
              <a:ext uri="{FF2B5EF4-FFF2-40B4-BE49-F238E27FC236}">
                <a16:creationId xmlns:a16="http://schemas.microsoft.com/office/drawing/2014/main" id="{A4A1DB29-EC67-D16E-03AD-9743A97C80DA}"/>
              </a:ext>
            </a:extLst>
          </p:cNvPr>
          <p:cNvSpPr txBox="1"/>
          <p:nvPr/>
        </p:nvSpPr>
        <p:spPr>
          <a:xfrm>
            <a:off x="1304097" y="6111714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3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8) in the positive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18696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2348" y="1691360"/>
            <a:ext cx="11256568" cy="442808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50EDDF9-6ACF-B374-4876-7D315221970D}"/>
              </a:ext>
            </a:extLst>
          </p:cNvPr>
          <p:cNvSpPr txBox="1"/>
          <p:nvPr/>
        </p:nvSpPr>
        <p:spPr>
          <a:xfrm>
            <a:off x="5687133" y="1513376"/>
            <a:ext cx="23065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Heliotrin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N-oxide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AB38D098-BF8D-2EE3-0022-1F23A07E12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464552"/>
              </p:ext>
            </p:extLst>
          </p:nvPr>
        </p:nvGraphicFramePr>
        <p:xfrm>
          <a:off x="8043095" y="1397759"/>
          <a:ext cx="2743200" cy="2843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2742480" imgH="2842920" progId="ChemDraw.Document.6.0">
                  <p:embed/>
                </p:oleObj>
              </mc:Choice>
              <mc:Fallback>
                <p:oleObj name="CS ChemDraw Drawing" r:id="rId3" imgW="2742480" imgH="2842920" progId="ChemDraw.Document.6.0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AB38D098-BF8D-2EE3-0022-1F23A07E12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043095" y="1397759"/>
                        <a:ext cx="2743200" cy="2843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4114D6DF-C8A3-3E89-241D-1FB0732B4E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1472708"/>
              </p:ext>
            </p:extLst>
          </p:nvPr>
        </p:nvGraphicFramePr>
        <p:xfrm>
          <a:off x="4934378" y="2074055"/>
          <a:ext cx="1752600" cy="1235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1752120" imgH="1235160" progId="ChemDraw.Document.6.0">
                  <p:embed/>
                </p:oleObj>
              </mc:Choice>
              <mc:Fallback>
                <p:oleObj name="CS ChemDraw Drawing" r:id="rId5" imgW="1752120" imgH="1235160" progId="ChemDraw.Document.6.0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4114D6DF-C8A3-3E89-241D-1FB0732B4E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934378" y="2074055"/>
                        <a:ext cx="1752600" cy="1235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3F939F23-27E5-9F93-B149-F56EBB24EA38}"/>
              </a:ext>
            </a:extLst>
          </p:cNvPr>
          <p:cNvCxnSpPr>
            <a:cxnSpLocks/>
          </p:cNvCxnSpPr>
          <p:nvPr/>
        </p:nvCxnSpPr>
        <p:spPr>
          <a:xfrm>
            <a:off x="4849392" y="4403352"/>
            <a:ext cx="638740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3E2A9239-C6FB-1506-C771-DF31F9EAE413}"/>
              </a:ext>
            </a:extLst>
          </p:cNvPr>
          <p:cNvSpPr txBox="1"/>
          <p:nvPr/>
        </p:nvSpPr>
        <p:spPr>
          <a:xfrm>
            <a:off x="6840391" y="3947370"/>
            <a:ext cx="1233435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 [M-158]</a:t>
            </a:r>
          </a:p>
        </p:txBody>
      </p:sp>
      <p:sp>
        <p:nvSpPr>
          <p:cNvPr id="5" name="TextBox 6">
            <a:extLst>
              <a:ext uri="{FF2B5EF4-FFF2-40B4-BE49-F238E27FC236}">
                <a16:creationId xmlns:a16="http://schemas.microsoft.com/office/drawing/2014/main" id="{C4D55904-F93B-C33C-9A7A-252903EC26FB}"/>
              </a:ext>
            </a:extLst>
          </p:cNvPr>
          <p:cNvSpPr txBox="1"/>
          <p:nvPr/>
        </p:nvSpPr>
        <p:spPr>
          <a:xfrm>
            <a:off x="1304097" y="6111714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4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15) in the positive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93555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4137" y="1205802"/>
            <a:ext cx="10183726" cy="410150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A52CD8C-8CCD-9B1B-ABE3-F7B51FF416E2}"/>
              </a:ext>
            </a:extLst>
          </p:cNvPr>
          <p:cNvSpPr txBox="1"/>
          <p:nvPr/>
        </p:nvSpPr>
        <p:spPr>
          <a:xfrm>
            <a:off x="5659735" y="1463264"/>
            <a:ext cx="16454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Europin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A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B1DC0A3-E571-91AF-5A9A-B1B88C85EC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485817"/>
              </p:ext>
            </p:extLst>
          </p:nvPr>
        </p:nvGraphicFramePr>
        <p:xfrm>
          <a:off x="6903557" y="1413132"/>
          <a:ext cx="2743200" cy="2843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2742480" imgH="2842920" progId="ChemDraw.Document.6.0">
                  <p:embed/>
                </p:oleObj>
              </mc:Choice>
              <mc:Fallback>
                <p:oleObj name="CS ChemDraw Drawing" r:id="rId4" imgW="2742480" imgH="2842920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B1DC0A3-E571-91AF-5A9A-B1B88C85EC0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903557" y="1413132"/>
                        <a:ext cx="2743200" cy="2843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8D82ABCB-80F8-F4A6-B5B9-DDCA15EAFE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1790246"/>
              </p:ext>
            </p:extLst>
          </p:nvPr>
        </p:nvGraphicFramePr>
        <p:xfrm>
          <a:off x="3185327" y="2570549"/>
          <a:ext cx="1537040" cy="10940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1735920" imgH="1235160" progId="ChemDraw.Document.6.0">
                  <p:embed/>
                </p:oleObj>
              </mc:Choice>
              <mc:Fallback>
                <p:oleObj name="CS ChemDraw Drawing" r:id="rId6" imgW="1735920" imgH="1235160" progId="ChemDraw.Document.6.0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8D82ABCB-80F8-F4A6-B5B9-DDCA15EAFE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185327" y="2570549"/>
                        <a:ext cx="1537040" cy="10940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6">
            <a:extLst>
              <a:ext uri="{FF2B5EF4-FFF2-40B4-BE49-F238E27FC236}">
                <a16:creationId xmlns:a16="http://schemas.microsoft.com/office/drawing/2014/main" id="{613AC0B3-1677-E862-FD9F-32E253B18757}"/>
              </a:ext>
            </a:extLst>
          </p:cNvPr>
          <p:cNvSpPr txBox="1"/>
          <p:nvPr/>
        </p:nvSpPr>
        <p:spPr>
          <a:xfrm>
            <a:off x="1756273" y="5444868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5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16) in the positive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70063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4137" y="1550689"/>
            <a:ext cx="10183726" cy="375662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ADFAF4E-AD82-033B-C997-9A75BBBE42C4}"/>
              </a:ext>
            </a:extLst>
          </p:cNvPr>
          <p:cNvSpPr txBox="1"/>
          <p:nvPr/>
        </p:nvSpPr>
        <p:spPr>
          <a:xfrm>
            <a:off x="6945054" y="1408578"/>
            <a:ext cx="21646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srgbClr val="212529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Uplandicine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0C1F14D-1C85-EBDB-C009-C45CD1FFD6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3810777"/>
              </p:ext>
            </p:extLst>
          </p:nvPr>
        </p:nvGraphicFramePr>
        <p:xfrm>
          <a:off x="4718745" y="1635798"/>
          <a:ext cx="3205163" cy="2470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3205440" imgH="2469960" progId="ChemDraw.Document.6.0">
                  <p:embed/>
                </p:oleObj>
              </mc:Choice>
              <mc:Fallback>
                <p:oleObj name="CS ChemDraw Drawing" r:id="rId4" imgW="3205440" imgH="2469960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30C1F14D-1C85-EBDB-C009-C45CD1FFD6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718745" y="1635798"/>
                        <a:ext cx="3205163" cy="2470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5FEC810-8D07-79A5-A862-BC78EE474D6D}"/>
              </a:ext>
            </a:extLst>
          </p:cNvPr>
          <p:cNvCxnSpPr>
            <a:cxnSpLocks/>
          </p:cNvCxnSpPr>
          <p:nvPr/>
        </p:nvCxnSpPr>
        <p:spPr>
          <a:xfrm>
            <a:off x="8606098" y="3833329"/>
            <a:ext cx="236670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208CE6D6-B7BE-C815-E8FD-FC57386039F8}"/>
              </a:ext>
            </a:extLst>
          </p:cNvPr>
          <p:cNvSpPr txBox="1"/>
          <p:nvPr/>
        </p:nvSpPr>
        <p:spPr>
          <a:xfrm>
            <a:off x="8807320" y="3394972"/>
            <a:ext cx="1127256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 [M-60]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5BAFD2C-8560-6343-BC27-B88827F7B525}"/>
              </a:ext>
            </a:extLst>
          </p:cNvPr>
          <p:cNvCxnSpPr/>
          <p:nvPr/>
        </p:nvCxnSpPr>
        <p:spPr>
          <a:xfrm>
            <a:off x="10008213" y="4457700"/>
            <a:ext cx="96458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D6DB5AE7-93DE-CBD8-1FF5-0F25C36FE30E}"/>
              </a:ext>
            </a:extLst>
          </p:cNvPr>
          <p:cNvSpPr txBox="1"/>
          <p:nvPr/>
        </p:nvSpPr>
        <p:spPr>
          <a:xfrm>
            <a:off x="10017739" y="4016322"/>
            <a:ext cx="955061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 [M-18]</a:t>
            </a:r>
          </a:p>
        </p:txBody>
      </p:sp>
      <p:sp>
        <p:nvSpPr>
          <p:cNvPr id="5" name="TextBox 6">
            <a:extLst>
              <a:ext uri="{FF2B5EF4-FFF2-40B4-BE49-F238E27FC236}">
                <a16:creationId xmlns:a16="http://schemas.microsoft.com/office/drawing/2014/main" id="{C09039C7-CAEF-EE97-C554-78124101692B}"/>
              </a:ext>
            </a:extLst>
          </p:cNvPr>
          <p:cNvSpPr txBox="1"/>
          <p:nvPr/>
        </p:nvSpPr>
        <p:spPr>
          <a:xfrm>
            <a:off x="1654977" y="5636272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6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27) in the positive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5D8BE9A0-5F25-8F4D-37A8-71F2BCF1A70C}"/>
              </a:ext>
            </a:extLst>
          </p:cNvPr>
          <p:cNvCxnSpPr/>
          <p:nvPr/>
        </p:nvCxnSpPr>
        <p:spPr>
          <a:xfrm flipH="1" flipV="1">
            <a:off x="3543005" y="3353599"/>
            <a:ext cx="331157" cy="40294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040E4C05-8758-1EB9-7112-FBF1539225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5079033"/>
              </p:ext>
            </p:extLst>
          </p:nvPr>
        </p:nvGraphicFramePr>
        <p:xfrm>
          <a:off x="2454834" y="2536763"/>
          <a:ext cx="1258887" cy="1306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1259640" imgH="1306800" progId="ChemDraw.Document.6.0">
                  <p:embed/>
                </p:oleObj>
              </mc:Choice>
              <mc:Fallback>
                <p:oleObj name="CS ChemDraw Drawing" r:id="rId6" imgW="1259640" imgH="1306800" progId="ChemDraw.Document.6.0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040E4C05-8758-1EB9-7112-FBF1539225D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454834" y="2536763"/>
                        <a:ext cx="1258887" cy="1306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716022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4137" y="1550689"/>
            <a:ext cx="10183726" cy="375662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4D361BE-3562-3D90-AE74-AED22C07EEA8}"/>
              </a:ext>
            </a:extLst>
          </p:cNvPr>
          <p:cNvSpPr txBox="1"/>
          <p:nvPr/>
        </p:nvSpPr>
        <p:spPr>
          <a:xfrm>
            <a:off x="5568903" y="15506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luganine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CB22B227-4D4B-82F1-9981-8D50CF441A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4542290"/>
              </p:ext>
            </p:extLst>
          </p:nvPr>
        </p:nvGraphicFramePr>
        <p:xfrm>
          <a:off x="3278751" y="2132722"/>
          <a:ext cx="3522750" cy="20254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4299120" imgH="2471400" progId="ChemDraw.Document.6.0">
                  <p:embed/>
                </p:oleObj>
              </mc:Choice>
              <mc:Fallback>
                <p:oleObj name="CS ChemDraw Drawing" r:id="rId4" imgW="4299120" imgH="247140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78751" y="2132722"/>
                        <a:ext cx="3522750" cy="20254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6">
            <a:extLst>
              <a:ext uri="{FF2B5EF4-FFF2-40B4-BE49-F238E27FC236}">
                <a16:creationId xmlns:a16="http://schemas.microsoft.com/office/drawing/2014/main" id="{BAF0313A-0F94-1B8D-C496-420B2110478F}"/>
              </a:ext>
            </a:extLst>
          </p:cNvPr>
          <p:cNvSpPr txBox="1"/>
          <p:nvPr/>
        </p:nvSpPr>
        <p:spPr>
          <a:xfrm>
            <a:off x="1654977" y="5642475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7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37) in the positive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60937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4137" y="1550689"/>
            <a:ext cx="10183726" cy="3756622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E343881F-1796-DB38-DBF9-C3B03C645423}"/>
              </a:ext>
            </a:extLst>
          </p:cNvPr>
          <p:cNvSpPr txBox="1"/>
          <p:nvPr/>
        </p:nvSpPr>
        <p:spPr>
          <a:xfrm>
            <a:off x="5588358" y="1319897"/>
            <a:ext cx="20674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i="0" u="none" strike="noStrike" kern="1200" cap="none" spc="0" normalizeH="0" baseline="0" noProof="0" dirty="0" err="1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Curassavine</a:t>
            </a:r>
            <a:endParaRPr kumimoji="0" lang="en-US" sz="1800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53B0588-A3C1-DF0A-1D56-1D8F081A63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3348855"/>
              </p:ext>
            </p:extLst>
          </p:nvPr>
        </p:nvGraphicFramePr>
        <p:xfrm>
          <a:off x="8230524" y="1640219"/>
          <a:ext cx="2663825" cy="1949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2664360" imgH="1950120" progId="ChemDraw.Document.6.0">
                  <p:embed/>
                </p:oleObj>
              </mc:Choice>
              <mc:Fallback>
                <p:oleObj name="CS ChemDraw Drawing" r:id="rId3" imgW="2664360" imgH="1950120" progId="ChemDraw.Document.6.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53B0588-A3C1-DF0A-1D56-1D8F081A63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230524" y="1640219"/>
                        <a:ext cx="2663825" cy="1949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B1DB6D2-4836-66EE-7674-5318F4129A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9592785"/>
              </p:ext>
            </p:extLst>
          </p:nvPr>
        </p:nvGraphicFramePr>
        <p:xfrm>
          <a:off x="2242197" y="2698750"/>
          <a:ext cx="1193800" cy="1460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1194480" imgH="1460160" progId="ChemDraw.Document.6.0">
                  <p:embed/>
                </p:oleObj>
              </mc:Choice>
              <mc:Fallback>
                <p:oleObj name="CS ChemDraw Drawing" r:id="rId5" imgW="1194480" imgH="1460160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FB1DB6D2-4836-66EE-7674-5318F4129A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42197" y="2698750"/>
                        <a:ext cx="1193800" cy="1460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1C38B93C-F59A-CFE7-4ED7-A57BFA72E9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7814593"/>
              </p:ext>
            </p:extLst>
          </p:nvPr>
        </p:nvGraphicFramePr>
        <p:xfrm>
          <a:off x="4375831" y="2197100"/>
          <a:ext cx="1362075" cy="10096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7" imgW="1638360" imgH="1214640" progId="ChemDraw.Document.6.0">
                  <p:embed/>
                </p:oleObj>
              </mc:Choice>
              <mc:Fallback>
                <p:oleObj name="CS ChemDraw Drawing" r:id="rId7" imgW="1638360" imgH="121464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375831" y="2197100"/>
                        <a:ext cx="1362075" cy="10096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956C5CD9-6D93-B9BF-0066-71B371E63522}"/>
              </a:ext>
            </a:extLst>
          </p:cNvPr>
          <p:cNvSpPr txBox="1"/>
          <p:nvPr/>
        </p:nvSpPr>
        <p:spPr>
          <a:xfrm>
            <a:off x="4448176" y="3281892"/>
            <a:ext cx="17526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 err="1"/>
              <a:t>trachelanthamidine</a:t>
            </a:r>
            <a:endParaRPr lang="en-US" sz="14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15D195A-0EB3-B477-F845-AC2077DD47C6}"/>
              </a:ext>
            </a:extLst>
          </p:cNvPr>
          <p:cNvSpPr txBox="1"/>
          <p:nvPr/>
        </p:nvSpPr>
        <p:spPr>
          <a:xfrm>
            <a:off x="2384085" y="2678444"/>
            <a:ext cx="132783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 err="1"/>
              <a:t>heliotridane</a:t>
            </a:r>
            <a:endParaRPr lang="en-US" sz="1400" dirty="0"/>
          </a:p>
        </p:txBody>
      </p:sp>
      <p:sp>
        <p:nvSpPr>
          <p:cNvPr id="6" name="TextBox 6">
            <a:extLst>
              <a:ext uri="{FF2B5EF4-FFF2-40B4-BE49-F238E27FC236}">
                <a16:creationId xmlns:a16="http://schemas.microsoft.com/office/drawing/2014/main" id="{37A3CF4F-E2F1-7125-1C07-F9781CCC9BF6}"/>
              </a:ext>
            </a:extLst>
          </p:cNvPr>
          <p:cNvSpPr txBox="1"/>
          <p:nvPr/>
        </p:nvSpPr>
        <p:spPr>
          <a:xfrm>
            <a:off x="1535209" y="5567247"/>
            <a:ext cx="88820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. Fig. S8: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SI-MS/MS</a:t>
            </a:r>
            <a:r>
              <a:rPr kumimoji="0" lang="en-US" sz="1800" b="0" i="0" u="none" strike="noStrike" kern="12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pectrum of metabolite (18) in the positive ionization mode.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742485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72</TotalTime>
  <Words>593</Words>
  <Application>Microsoft Office PowerPoint</Application>
  <PresentationFormat>Widescreen</PresentationFormat>
  <Paragraphs>86</Paragraphs>
  <Slides>26</Slides>
  <Notes>14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3" baseType="lpstr">
      <vt:lpstr>Arial</vt:lpstr>
      <vt:lpstr>Calibri</vt:lpstr>
      <vt:lpstr>Calibri Light</vt:lpstr>
      <vt:lpstr>Google Sans</vt:lpstr>
      <vt:lpstr>Times New Roman</vt:lpstr>
      <vt:lpstr>1_Office Theme</vt:lpstr>
      <vt:lpstr>CS ChemDraw Drawing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ia rasheed</dc:creator>
  <cp:lastModifiedBy>Abdelsamed Elshamy</cp:lastModifiedBy>
  <cp:revision>61</cp:revision>
  <dcterms:created xsi:type="dcterms:W3CDTF">2023-10-12T18:43:44Z</dcterms:created>
  <dcterms:modified xsi:type="dcterms:W3CDTF">2025-08-14T12:22:47Z</dcterms:modified>
</cp:coreProperties>
</file>